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0" r:id="rId2"/>
    <p:sldId id="258" r:id="rId3"/>
    <p:sldId id="257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627"/>
    <p:restoredTop sz="94694"/>
  </p:normalViewPr>
  <p:slideViewPr>
    <p:cSldViewPr snapToGrid="0" snapToObjects="1">
      <p:cViewPr>
        <p:scale>
          <a:sx n="181" d="100"/>
          <a:sy n="181" d="100"/>
        </p:scale>
        <p:origin x="1168" y="-58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6F3781-6FED-2F4D-9DF6-546880EB14CC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BA6941-A14C-2443-B951-4C00E70CD3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7375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231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1352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5679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7698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327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994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0021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37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695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88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885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4808F-5DA6-E047-A518-439BB515EAFA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F0775-FBCA-F84D-B4EE-F080C58101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393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3" Type="http://schemas.openxmlformats.org/officeDocument/2006/relationships/image" Target="../media/image6.tif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9.png"/><Relationship Id="rId7" Type="http://schemas.openxmlformats.org/officeDocument/2006/relationships/image" Target="../media/image17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Engineering drawing&#10;&#10;Description automatically generated with low confidence">
            <a:extLst>
              <a:ext uri="{FF2B5EF4-FFF2-40B4-BE49-F238E27FC236}">
                <a16:creationId xmlns:a16="http://schemas.microsoft.com/office/drawing/2014/main" id="{4A663A16-0957-5D4F-A3B6-6C91F5C117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991" y="699180"/>
            <a:ext cx="2293794" cy="33609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54F192F-A733-8444-BBE8-DED5DF18119D}"/>
              </a:ext>
            </a:extLst>
          </p:cNvPr>
          <p:cNvSpPr txBox="1"/>
          <p:nvPr/>
        </p:nvSpPr>
        <p:spPr>
          <a:xfrm>
            <a:off x="275869" y="4176487"/>
            <a:ext cx="6306261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| Frequency of hematopoietic cells in mesenteric lymph nodes of untreated C57BL/6 mouse. </a:t>
            </a:r>
          </a:p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esenteric lymph nodes were isolated from untreated C57BL/6 mouse and enzymatically processed to isolate hematopoietic cells followed by flow cytometric analysis to evaluate cell populations. Error bars represent Mean± SD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group of colorful lights in a dark room&#10;&#10;Description automatically generated with low confidence">
            <a:extLst>
              <a:ext uri="{FF2B5EF4-FFF2-40B4-BE49-F238E27FC236}">
                <a16:creationId xmlns:a16="http://schemas.microsoft.com/office/drawing/2014/main" id="{242477D7-912E-C94F-A466-83F6A67791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5125" y="582795"/>
            <a:ext cx="2199036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275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photo, sitting, different, monitor&#10;&#10;Description automatically generated">
            <a:extLst>
              <a:ext uri="{FF2B5EF4-FFF2-40B4-BE49-F238E27FC236}">
                <a16:creationId xmlns:a16="http://schemas.microsoft.com/office/drawing/2014/main" id="{77E70465-01CA-3C40-8F52-7C28D32F20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763" y="622806"/>
            <a:ext cx="5891775" cy="1129226"/>
          </a:xfrm>
          <a:prstGeom prst="rect">
            <a:avLst/>
          </a:prstGeom>
        </p:spPr>
      </p:pic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A08D97CC-0799-604E-A088-DCF2191C6A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4670" r="37375"/>
          <a:stretch/>
        </p:blipFill>
        <p:spPr>
          <a:xfrm>
            <a:off x="311328" y="2188961"/>
            <a:ext cx="5182560" cy="157223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9493E40-8E98-C449-AD89-2A953CC32652}"/>
              </a:ext>
            </a:extLst>
          </p:cNvPr>
          <p:cNvSpPr txBox="1"/>
          <p:nvPr/>
        </p:nvSpPr>
        <p:spPr>
          <a:xfrm>
            <a:off x="316763" y="3675727"/>
            <a:ext cx="6143031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 | Gating strategies (A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ating strategy for subsets of lymph node stromal cells. Cells were pre-gated for living singlets, and further gated for CD45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2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nd subsequent gating of fibroblastic reticular cells (gp38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, lymph endothelial cells gp38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blood endothelial cells (gp38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and double negative cells (gp38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based on the expression of cell surface receptors podoplanin (gp38) and PECAM-1(CD31)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ating strategy for allogenic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 cells subsequent to allo-HCT. Cells were pre-gated for living singlets, and further gated for CD90.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nd subsequently evaluated for expression of cell surface and intracellular molecules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5744686-26AE-6646-98C0-07D786B47DD4}"/>
              </a:ext>
            </a:extLst>
          </p:cNvPr>
          <p:cNvSpPr txBox="1"/>
          <p:nvPr/>
        </p:nvSpPr>
        <p:spPr>
          <a:xfrm>
            <a:off x="142051" y="20614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3AF1B22-E43C-3E43-BB65-2E0AA028896B}"/>
              </a:ext>
            </a:extLst>
          </p:cNvPr>
          <p:cNvSpPr txBox="1"/>
          <p:nvPr/>
        </p:nvSpPr>
        <p:spPr>
          <a:xfrm>
            <a:off x="142051" y="179852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77726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TextBox 333">
            <a:extLst>
              <a:ext uri="{FF2B5EF4-FFF2-40B4-BE49-F238E27FC236}">
                <a16:creationId xmlns:a16="http://schemas.microsoft.com/office/drawing/2014/main" id="{EABE72E1-0ACA-684B-8578-5C91C80B10AC}"/>
              </a:ext>
            </a:extLst>
          </p:cNvPr>
          <p:cNvSpPr txBox="1"/>
          <p:nvPr/>
        </p:nvSpPr>
        <p:spPr>
          <a:xfrm>
            <a:off x="250266" y="1360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6BF5620-BA71-2B4D-8679-749FB14E6C6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751" t="17674" r="29868" b="31993"/>
          <a:stretch/>
        </p:blipFill>
        <p:spPr>
          <a:xfrm>
            <a:off x="524988" y="626909"/>
            <a:ext cx="1415172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BEA15A6-D914-0845-A64F-C392B8D7CDF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734" t="10558" r="29549" b="39108"/>
          <a:stretch/>
        </p:blipFill>
        <p:spPr>
          <a:xfrm>
            <a:off x="2065040" y="628130"/>
            <a:ext cx="1415173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7029742-6C67-004D-9790-BC8BE472575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6910" t="4196" r="6473" b="16942"/>
          <a:stretch/>
        </p:blipFill>
        <p:spPr>
          <a:xfrm>
            <a:off x="3489021" y="524554"/>
            <a:ext cx="124130" cy="948098"/>
          </a:xfrm>
          <a:prstGeom prst="rect">
            <a:avLst/>
          </a:prstGeom>
          <a:ln>
            <a:noFill/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DE02A98F-7EFD-AF4A-87FA-16ED27C44796}"/>
              </a:ext>
            </a:extLst>
          </p:cNvPr>
          <p:cNvSpPr txBox="1"/>
          <p:nvPr/>
        </p:nvSpPr>
        <p:spPr>
          <a:xfrm rot="16200000">
            <a:off x="-26124" y="959953"/>
            <a:ext cx="8867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+6 allo-HCT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5DD4659E-827C-4845-BEBE-A0CADD77195D}"/>
              </a:ext>
            </a:extLst>
          </p:cNvPr>
          <p:cNvSpPr txBox="1"/>
          <p:nvPr/>
        </p:nvSpPr>
        <p:spPr>
          <a:xfrm>
            <a:off x="978517" y="414731"/>
            <a:ext cx="6399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9BAE1260-BA02-4E41-A7D7-3A13FDB69EBE}"/>
              </a:ext>
            </a:extLst>
          </p:cNvPr>
          <p:cNvSpPr txBox="1"/>
          <p:nvPr/>
        </p:nvSpPr>
        <p:spPr>
          <a:xfrm>
            <a:off x="2185250" y="275344"/>
            <a:ext cx="123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(mLNs transplanted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11DF3C56-6D61-1047-9D87-BCB9AEB27354}"/>
              </a:ext>
            </a:extLst>
          </p:cNvPr>
          <p:cNvCxnSpPr>
            <a:cxnSpLocks/>
          </p:cNvCxnSpPr>
          <p:nvPr/>
        </p:nvCxnSpPr>
        <p:spPr>
          <a:xfrm flipH="1">
            <a:off x="2478034" y="961123"/>
            <a:ext cx="87366" cy="122912"/>
          </a:xfrm>
          <a:prstGeom prst="straightConnector1">
            <a:avLst/>
          </a:prstGeom>
          <a:ln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9" name="TextBox 318">
            <a:extLst>
              <a:ext uri="{FF2B5EF4-FFF2-40B4-BE49-F238E27FC236}">
                <a16:creationId xmlns:a16="http://schemas.microsoft.com/office/drawing/2014/main" id="{FFFDED4B-F95B-3F48-850E-A9E5B1EFCA84}"/>
              </a:ext>
            </a:extLst>
          </p:cNvPr>
          <p:cNvSpPr txBox="1"/>
          <p:nvPr/>
        </p:nvSpPr>
        <p:spPr>
          <a:xfrm>
            <a:off x="250266" y="170451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C28757A1-CE2A-AD48-803F-5898E5516BFE}"/>
              </a:ext>
            </a:extLst>
          </p:cNvPr>
          <p:cNvSpPr txBox="1"/>
          <p:nvPr/>
        </p:nvSpPr>
        <p:spPr>
          <a:xfrm>
            <a:off x="4416241" y="30163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mLNs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4286494E-A35B-C54D-925D-C2A1E566EE94}"/>
              </a:ext>
            </a:extLst>
          </p:cNvPr>
          <p:cNvSpPr txBox="1"/>
          <p:nvPr/>
        </p:nvSpPr>
        <p:spPr>
          <a:xfrm>
            <a:off x="5700800" y="276642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IT + PPs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2F9D8CC0-A370-A84A-B301-F3882784EE79}"/>
              </a:ext>
            </a:extLst>
          </p:cNvPr>
          <p:cNvSpPr txBox="1"/>
          <p:nvPr/>
        </p:nvSpPr>
        <p:spPr>
          <a:xfrm>
            <a:off x="1843699" y="17210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55F332B6-D8C1-324B-9647-432D1ADFBFC3}"/>
              </a:ext>
            </a:extLst>
          </p:cNvPr>
          <p:cNvSpPr txBox="1"/>
          <p:nvPr/>
        </p:nvSpPr>
        <p:spPr>
          <a:xfrm>
            <a:off x="258850" y="31214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EF5F1D22-90C2-1845-B87C-77585E244554}"/>
              </a:ext>
            </a:extLst>
          </p:cNvPr>
          <p:cNvSpPr txBox="1"/>
          <p:nvPr/>
        </p:nvSpPr>
        <p:spPr>
          <a:xfrm>
            <a:off x="250266" y="481545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314CE442-1B9D-614B-BC8D-D001491C131E}"/>
              </a:ext>
            </a:extLst>
          </p:cNvPr>
          <p:cNvSpPr txBox="1"/>
          <p:nvPr/>
        </p:nvSpPr>
        <p:spPr>
          <a:xfrm>
            <a:off x="275869" y="6619545"/>
            <a:ext cx="6306261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| Allogenic CD4</a:t>
            </a:r>
            <a:r>
              <a:rPr lang="en-GB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 are adequately activated in the transplanted mLNs in the effector phase of aGvHD. </a:t>
            </a: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LI signal and quantification from adoptively transplanted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luc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 cells on d+6 of allo-HCT in mLNs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bsolute numbers of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 cells on d+6 of allo-HCT in mLNs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ean fluorescence intensity (MFI) of CD44 and integrin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n donor T cells d+6 of allo-HCT in mLNs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liferative capacity of donor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 cells analysed by expression of Ki67 d+6 of allo-HCT in mLNs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Differentiation of donor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 cells into naïve, effector, central memory (CM) and effector/ effector memory (EM) on basis of CD44 and CD62L expression d+6 of allo-HCT in mLNs. Data pooled from three mice. Error bars represent Mean± SD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6148EC3-C815-524E-AD49-6DAA314BA804}"/>
              </a:ext>
            </a:extLst>
          </p:cNvPr>
          <p:cNvSpPr txBox="1"/>
          <p:nvPr/>
        </p:nvSpPr>
        <p:spPr>
          <a:xfrm>
            <a:off x="811869" y="3433657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4A5FFB3-E3AE-784D-AD91-7CB16044CDEF}"/>
              </a:ext>
            </a:extLst>
          </p:cNvPr>
          <p:cNvSpPr txBox="1"/>
          <p:nvPr/>
        </p:nvSpPr>
        <p:spPr>
          <a:xfrm>
            <a:off x="1616293" y="3294270"/>
            <a:ext cx="1117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(mLNs transplanted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3CC9472-CC5B-BA41-B6F9-C49C4AD12139}"/>
              </a:ext>
            </a:extLst>
          </p:cNvPr>
          <p:cNvSpPr txBox="1"/>
          <p:nvPr/>
        </p:nvSpPr>
        <p:spPr>
          <a:xfrm>
            <a:off x="3474271" y="396887"/>
            <a:ext cx="235627" cy="112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Luminescence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5A89176-2651-2D48-8E5F-C4C5B0A68036}"/>
              </a:ext>
            </a:extLst>
          </p:cNvPr>
          <p:cNvSpPr txBox="1"/>
          <p:nvPr/>
        </p:nvSpPr>
        <p:spPr>
          <a:xfrm>
            <a:off x="3449957" y="1559227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" dirty="0" err="1">
                <a:latin typeface="Arial" panose="020B0604020202020204" pitchFamily="34" charset="0"/>
                <a:cs typeface="Arial" panose="020B0604020202020204" pitchFamily="34" charset="0"/>
              </a:rPr>
              <a:t>Color</a:t>
            </a:r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 Scale</a:t>
            </a:r>
          </a:p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Min = 3.74e3</a:t>
            </a:r>
          </a:p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Max = 9.11e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E82E124-622E-6D4F-A72B-CA3209FDAA70}"/>
              </a:ext>
            </a:extLst>
          </p:cNvPr>
          <p:cNvSpPr txBox="1"/>
          <p:nvPr/>
        </p:nvSpPr>
        <p:spPr>
          <a:xfrm>
            <a:off x="3452128" y="1420726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Radiance</a:t>
            </a:r>
          </a:p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(p/sec/cm</a:t>
            </a:r>
            <a:r>
              <a:rPr lang="en-GB" sz="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400" dirty="0" err="1"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4" name="Picture 13" descr="A close up of a logo&#10;&#10;Description automatically generated">
            <a:extLst>
              <a:ext uri="{FF2B5EF4-FFF2-40B4-BE49-F238E27FC236}">
                <a16:creationId xmlns:a16="http://schemas.microsoft.com/office/drawing/2014/main" id="{B5D9FC9D-5455-A740-A1D4-C5C35C095B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4922" y="3614083"/>
            <a:ext cx="2210644" cy="110713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A1C3AC4-9DF5-6045-A2CF-AD0B9A18C72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3870"/>
          <a:stretch/>
        </p:blipFill>
        <p:spPr>
          <a:xfrm>
            <a:off x="450192" y="5284775"/>
            <a:ext cx="2248782" cy="1122018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5EF9F92E-2573-BA4E-A85D-3F9D439BDA80}"/>
              </a:ext>
            </a:extLst>
          </p:cNvPr>
          <p:cNvSpPr txBox="1"/>
          <p:nvPr/>
        </p:nvSpPr>
        <p:spPr>
          <a:xfrm>
            <a:off x="633135" y="5114593"/>
            <a:ext cx="9460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VB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 C57BL/6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59D05BB-C189-CC44-B5E2-B2FE384BCEC3}"/>
              </a:ext>
            </a:extLst>
          </p:cNvPr>
          <p:cNvSpPr txBox="1"/>
          <p:nvPr/>
        </p:nvSpPr>
        <p:spPr>
          <a:xfrm>
            <a:off x="1599462" y="4991483"/>
            <a:ext cx="11512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VB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 C57BL/6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(Transplanted mLNs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427CC543-1174-3B4A-A6BB-B87191D55DC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-1367" r="49421" b="55849"/>
          <a:stretch/>
        </p:blipFill>
        <p:spPr>
          <a:xfrm>
            <a:off x="2113038" y="2087499"/>
            <a:ext cx="1109524" cy="1080000"/>
          </a:xfrm>
          <a:prstGeom prst="rect">
            <a:avLst/>
          </a:prstGeom>
        </p:spPr>
      </p:pic>
      <p:pic>
        <p:nvPicPr>
          <p:cNvPr id="11" name="Picture 10" descr="A screenshot of a cell phone&#10;&#10;Description automatically generated">
            <a:extLst>
              <a:ext uri="{FF2B5EF4-FFF2-40B4-BE49-F238E27FC236}">
                <a16:creationId xmlns:a16="http://schemas.microsoft.com/office/drawing/2014/main" id="{427FB78D-A3FC-8942-8DE0-370CF2080B9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1825" b="55094"/>
          <a:stretch/>
        </p:blipFill>
        <p:spPr>
          <a:xfrm>
            <a:off x="4375459" y="2075143"/>
            <a:ext cx="1073055" cy="1080000"/>
          </a:xfrm>
          <a:prstGeom prst="rect">
            <a:avLst/>
          </a:prstGeom>
        </p:spPr>
      </p:pic>
      <p:pic>
        <p:nvPicPr>
          <p:cNvPr id="15" name="Picture 14" descr="A picture containing light&#10;&#10;Description automatically generated">
            <a:extLst>
              <a:ext uri="{FF2B5EF4-FFF2-40B4-BE49-F238E27FC236}">
                <a16:creationId xmlns:a16="http://schemas.microsoft.com/office/drawing/2014/main" id="{AA9CA9E7-B30C-6C4B-BB38-989759FDB53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5313" r="44444"/>
          <a:stretch/>
        </p:blipFill>
        <p:spPr>
          <a:xfrm>
            <a:off x="2667852" y="5263140"/>
            <a:ext cx="1673984" cy="1080000"/>
          </a:xfrm>
          <a:prstGeom prst="rect">
            <a:avLst/>
          </a:prstGeom>
        </p:spPr>
      </p:pic>
      <p:pic>
        <p:nvPicPr>
          <p:cNvPr id="19" name="Picture 18" descr="A picture containing blur&#10;&#10;Description automatically generated">
            <a:extLst>
              <a:ext uri="{FF2B5EF4-FFF2-40B4-BE49-F238E27FC236}">
                <a16:creationId xmlns:a16="http://schemas.microsoft.com/office/drawing/2014/main" id="{475F0C42-1168-0E43-97F4-9666B47EB94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49573"/>
          <a:stretch/>
        </p:blipFill>
        <p:spPr>
          <a:xfrm>
            <a:off x="2661775" y="3504938"/>
            <a:ext cx="1269652" cy="1080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BD2FCF6-497F-F04A-B404-19FC826A01F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53878"/>
          <a:stretch/>
        </p:blipFill>
        <p:spPr>
          <a:xfrm>
            <a:off x="3776085" y="492876"/>
            <a:ext cx="1389327" cy="1080000"/>
          </a:xfrm>
          <a:prstGeom prst="rect">
            <a:avLst/>
          </a:prstGeom>
        </p:spPr>
      </p:pic>
      <p:pic>
        <p:nvPicPr>
          <p:cNvPr id="25" name="Picture 24" descr="A picture containing indoor, blur&#10;&#10;Description automatically generated">
            <a:extLst>
              <a:ext uri="{FF2B5EF4-FFF2-40B4-BE49-F238E27FC236}">
                <a16:creationId xmlns:a16="http://schemas.microsoft.com/office/drawing/2014/main" id="{16E93CC9-954C-0143-8D15-9A4B3385CDC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53565"/>
          <a:stretch/>
        </p:blipFill>
        <p:spPr>
          <a:xfrm>
            <a:off x="5204879" y="498229"/>
            <a:ext cx="1385968" cy="1080000"/>
          </a:xfrm>
          <a:prstGeom prst="rect">
            <a:avLst/>
          </a:prstGeom>
        </p:spPr>
      </p:pic>
      <p:pic>
        <p:nvPicPr>
          <p:cNvPr id="3" name="Picture 2" descr="A picture containing indoor, blur&#10;&#10;Description automatically generated">
            <a:extLst>
              <a:ext uri="{FF2B5EF4-FFF2-40B4-BE49-F238E27FC236}">
                <a16:creationId xmlns:a16="http://schemas.microsoft.com/office/drawing/2014/main" id="{B696FF00-9E12-FE40-BA4E-0E21022BFBB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9162"/>
          <a:stretch/>
        </p:blipFill>
        <p:spPr>
          <a:xfrm>
            <a:off x="470327" y="2030462"/>
            <a:ext cx="1384300" cy="108000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C6959A00-4E6E-9948-B0B7-009954325370}"/>
              </a:ext>
            </a:extLst>
          </p:cNvPr>
          <p:cNvSpPr txBox="1"/>
          <p:nvPr/>
        </p:nvSpPr>
        <p:spPr>
          <a:xfrm>
            <a:off x="1616293" y="1267628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Ns</a:t>
            </a:r>
            <a:endParaRPr lang="en-GB" sz="600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CD0AF81-29DD-5043-980E-28B382AB2ECF}"/>
              </a:ext>
            </a:extLst>
          </p:cNvPr>
          <p:cNvSpPr txBox="1"/>
          <p:nvPr/>
        </p:nvSpPr>
        <p:spPr>
          <a:xfrm>
            <a:off x="1361223" y="1075369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en-GB" sz="6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715B2CA-C79B-5D49-944B-214C16784311}"/>
              </a:ext>
            </a:extLst>
          </p:cNvPr>
          <p:cNvSpPr txBox="1"/>
          <p:nvPr/>
        </p:nvSpPr>
        <p:spPr>
          <a:xfrm>
            <a:off x="1276020" y="805430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ngs</a:t>
            </a:r>
            <a:endParaRPr lang="en-GB" sz="600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9676989-5AE4-F748-94FB-A3D8901693B1}"/>
              </a:ext>
            </a:extLst>
          </p:cNvPr>
          <p:cNvSpPr txBox="1"/>
          <p:nvPr/>
        </p:nvSpPr>
        <p:spPr>
          <a:xfrm>
            <a:off x="1556946" y="588946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en-GB" sz="600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20048D6-66E5-2740-A48A-892F1816C538}"/>
              </a:ext>
            </a:extLst>
          </p:cNvPr>
          <p:cNvSpPr txBox="1"/>
          <p:nvPr/>
        </p:nvSpPr>
        <p:spPr>
          <a:xfrm>
            <a:off x="667213" y="596031"/>
            <a:ext cx="31130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IT</a:t>
            </a:r>
            <a:endParaRPr lang="en-GB" sz="600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93AC5BA-5A8D-4641-B10B-4BABA52683B9}"/>
              </a:ext>
            </a:extLst>
          </p:cNvPr>
          <p:cNvSpPr txBox="1"/>
          <p:nvPr/>
        </p:nvSpPr>
        <p:spPr>
          <a:xfrm>
            <a:off x="1017757" y="829338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Ns</a:t>
            </a:r>
            <a:endParaRPr lang="en-GB" sz="600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2DAE2448-4D4C-1B4D-A237-96E5EF9F5496}"/>
              </a:ext>
            </a:extLst>
          </p:cNvPr>
          <p:cNvCxnSpPr>
            <a:cxnSpLocks/>
          </p:cNvCxnSpPr>
          <p:nvPr/>
        </p:nvCxnSpPr>
        <p:spPr>
          <a:xfrm flipH="1">
            <a:off x="902732" y="961123"/>
            <a:ext cx="180000" cy="36000"/>
          </a:xfrm>
          <a:prstGeom prst="straightConnector1">
            <a:avLst/>
          </a:prstGeom>
          <a:ln cap="flat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1418EAA2-5C7A-AE4F-B201-801EA7FDE23C}"/>
              </a:ext>
            </a:extLst>
          </p:cNvPr>
          <p:cNvSpPr txBox="1"/>
          <p:nvPr/>
        </p:nvSpPr>
        <p:spPr>
          <a:xfrm>
            <a:off x="3519680" y="1088594"/>
            <a:ext cx="27924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GB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2BDCED8-1806-7E4B-B968-C40F7F71A698}"/>
              </a:ext>
            </a:extLst>
          </p:cNvPr>
          <p:cNvSpPr txBox="1"/>
          <p:nvPr/>
        </p:nvSpPr>
        <p:spPr>
          <a:xfrm>
            <a:off x="3522855" y="897800"/>
            <a:ext cx="21352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EAB3714-93FB-DD4B-9C2D-0F8A14D9C46F}"/>
              </a:ext>
            </a:extLst>
          </p:cNvPr>
          <p:cNvSpPr txBox="1"/>
          <p:nvPr/>
        </p:nvSpPr>
        <p:spPr>
          <a:xfrm>
            <a:off x="3525112" y="701499"/>
            <a:ext cx="21352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5D6FBF9-54DD-4942-9350-DCD051DE703B}"/>
              </a:ext>
            </a:extLst>
          </p:cNvPr>
          <p:cNvSpPr txBox="1"/>
          <p:nvPr/>
        </p:nvSpPr>
        <p:spPr>
          <a:xfrm>
            <a:off x="3522973" y="499866"/>
            <a:ext cx="21352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3C740AC-7E3B-6F49-9FA6-D0692A9BD1E1}"/>
              </a:ext>
            </a:extLst>
          </p:cNvPr>
          <p:cNvSpPr txBox="1"/>
          <p:nvPr/>
        </p:nvSpPr>
        <p:spPr>
          <a:xfrm>
            <a:off x="3521157" y="1291542"/>
            <a:ext cx="21352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CE328802-8451-AF46-9A6F-F2ECF7676ED3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54814"/>
          <a:stretch/>
        </p:blipFill>
        <p:spPr>
          <a:xfrm>
            <a:off x="5462457" y="1960478"/>
            <a:ext cx="1103201" cy="10800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8BA51930-F4AF-5E48-A7E5-81B280352EB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53275"/>
          <a:stretch/>
        </p:blipFill>
        <p:spPr>
          <a:xfrm>
            <a:off x="3218650" y="1991356"/>
            <a:ext cx="1073494" cy="10800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DF2A5BE2-BEEC-0645-BE3B-BFC7E934B653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94817" y="3593061"/>
            <a:ext cx="1581778" cy="404526"/>
          </a:xfrm>
          <a:prstGeom prst="rect">
            <a:avLst/>
          </a:prstGeom>
        </p:spPr>
      </p:pic>
      <p:grpSp>
        <p:nvGrpSpPr>
          <p:cNvPr id="54" name="Group 53">
            <a:extLst>
              <a:ext uri="{FF2B5EF4-FFF2-40B4-BE49-F238E27FC236}">
                <a16:creationId xmlns:a16="http://schemas.microsoft.com/office/drawing/2014/main" id="{5B004196-7124-6B47-8093-4840BAC59555}"/>
              </a:ext>
            </a:extLst>
          </p:cNvPr>
          <p:cNvGrpSpPr/>
          <p:nvPr/>
        </p:nvGrpSpPr>
        <p:grpSpPr>
          <a:xfrm>
            <a:off x="4048280" y="4021572"/>
            <a:ext cx="1775310" cy="536851"/>
            <a:chOff x="5548226" y="4534163"/>
            <a:chExt cx="1775310" cy="536851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7E548CF-54E2-9945-8643-F8445AD345CA}"/>
                </a:ext>
              </a:extLst>
            </p:cNvPr>
            <p:cNvSpPr txBox="1"/>
            <p:nvPr/>
          </p:nvSpPr>
          <p:spPr>
            <a:xfrm>
              <a:off x="5670337" y="4534163"/>
              <a:ext cx="7505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FMO control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4B32E41F-0AE0-7747-B09B-776B018BF9DC}"/>
                </a:ext>
              </a:extLst>
            </p:cNvPr>
            <p:cNvSpPr txBox="1"/>
            <p:nvPr/>
          </p:nvSpPr>
          <p:spPr>
            <a:xfrm>
              <a:off x="5663285" y="4704941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allo-HCT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D4EB72E-58B1-B242-867D-38035656FDF9}"/>
                </a:ext>
              </a:extLst>
            </p:cNvPr>
            <p:cNvSpPr txBox="1"/>
            <p:nvPr/>
          </p:nvSpPr>
          <p:spPr>
            <a:xfrm>
              <a:off x="5666142" y="4855570"/>
              <a:ext cx="16573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allo-HCT (Transplanted mLNs)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92DF704A-BF11-7D46-9538-7AA0B4CE7261}"/>
                </a:ext>
              </a:extLst>
            </p:cNvPr>
            <p:cNvCxnSpPr>
              <a:cxnSpLocks/>
            </p:cNvCxnSpPr>
            <p:nvPr/>
          </p:nvCxnSpPr>
          <p:spPr>
            <a:xfrm>
              <a:off x="5548718" y="4813869"/>
              <a:ext cx="150329" cy="0"/>
            </a:xfrm>
            <a:prstGeom prst="line">
              <a:avLst/>
            </a:prstGeom>
            <a:ln w="19050">
              <a:solidFill>
                <a:srgbClr val="3C17E8"/>
              </a:solidFill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CA4B8DD3-300E-5A4D-B1B8-262D58C304B1}"/>
                </a:ext>
              </a:extLst>
            </p:cNvPr>
            <p:cNvCxnSpPr>
              <a:cxnSpLocks/>
            </p:cNvCxnSpPr>
            <p:nvPr/>
          </p:nvCxnSpPr>
          <p:spPr>
            <a:xfrm>
              <a:off x="5548226" y="4961167"/>
              <a:ext cx="150329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08123F35-CD8B-944C-B2BA-E7E857611C34}"/>
                </a:ext>
              </a:extLst>
            </p:cNvPr>
            <p:cNvSpPr/>
            <p:nvPr/>
          </p:nvSpPr>
          <p:spPr>
            <a:xfrm>
              <a:off x="5548717" y="4611018"/>
              <a:ext cx="144000" cy="720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7042654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1CDE13F-A501-FB4B-B484-1AEB0915539B}"/>
              </a:ext>
            </a:extLst>
          </p:cNvPr>
          <p:cNvSpPr txBox="1"/>
          <p:nvPr/>
        </p:nvSpPr>
        <p:spPr>
          <a:xfrm>
            <a:off x="275869" y="4569077"/>
            <a:ext cx="630626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 | mLNs surgically transplanted does not influence the induction of gastro-intestinal GvHD in the effector phase of allo-HCT (A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ean fluorescence intensity (MFI) of CD44 and integrin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n donor T cells d+6 of allo-HCT in GIT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liferative capacity of donor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 cells analysed by expression of Ki67 d+6 of allo-HCT in GIT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Differentiation of donor CD4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 cells into naïve, effector, central memory (CM) and effector/ effector memory (EM) on basis of CD44 and CD62L expression d+6 of allo-HCT in GIT. Data pooled from three mice. Error bars represent Mean± SD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E8C594E-9308-8C46-8C56-1DF95E3F43E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858" t="50391" r="33851" b="27956"/>
          <a:stretch/>
        </p:blipFill>
        <p:spPr>
          <a:xfrm>
            <a:off x="275869" y="2009182"/>
            <a:ext cx="2418286" cy="108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D8F1E44-B379-A446-9446-0DCE57B0F15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6157" t="1742" r="49537" b="75948"/>
          <a:stretch/>
        </p:blipFill>
        <p:spPr>
          <a:xfrm>
            <a:off x="275869" y="579524"/>
            <a:ext cx="1108468" cy="1080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A5E9CAC-DF3B-924A-BC9B-2603352C7C2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842" t="1742" r="34626" b="75948"/>
          <a:stretch/>
        </p:blipFill>
        <p:spPr>
          <a:xfrm>
            <a:off x="2513154" y="579524"/>
            <a:ext cx="1048450" cy="108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922A402-6E76-7244-BB3A-34BA728C34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858" t="26207" r="33851" b="51486"/>
          <a:stretch/>
        </p:blipFill>
        <p:spPr>
          <a:xfrm>
            <a:off x="311328" y="3381355"/>
            <a:ext cx="2347368" cy="1080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E0F6D68-C394-634A-B6C9-980C003C4C34}"/>
              </a:ext>
            </a:extLst>
          </p:cNvPr>
          <p:cNvSpPr txBox="1"/>
          <p:nvPr/>
        </p:nvSpPr>
        <p:spPr>
          <a:xfrm>
            <a:off x="706426" y="1843651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C386447-7F3E-9A4A-91AD-EA2CB3BB2AF7}"/>
              </a:ext>
            </a:extLst>
          </p:cNvPr>
          <p:cNvSpPr txBox="1"/>
          <p:nvPr/>
        </p:nvSpPr>
        <p:spPr>
          <a:xfrm>
            <a:off x="1559709" y="1720541"/>
            <a:ext cx="11176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(mLNs transplanted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8AA4C6-8C38-EC44-9BD6-878B29DCC411}"/>
              </a:ext>
            </a:extLst>
          </p:cNvPr>
          <p:cNvSpPr txBox="1"/>
          <p:nvPr/>
        </p:nvSpPr>
        <p:spPr>
          <a:xfrm>
            <a:off x="719827" y="3237682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C45F23B-E737-1B47-8C7A-035371740EAA}"/>
              </a:ext>
            </a:extLst>
          </p:cNvPr>
          <p:cNvSpPr txBox="1"/>
          <p:nvPr/>
        </p:nvSpPr>
        <p:spPr>
          <a:xfrm>
            <a:off x="1524250" y="3114572"/>
            <a:ext cx="11176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llo-HCT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(mLNs transplanted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62BC09E-7BB2-0548-891D-F025F376EEED}"/>
              </a:ext>
            </a:extLst>
          </p:cNvPr>
          <p:cNvSpPr txBox="1"/>
          <p:nvPr/>
        </p:nvSpPr>
        <p:spPr>
          <a:xfrm>
            <a:off x="142051" y="20614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198C1E1-37AF-BF40-AA4C-556A3BD436BD}"/>
              </a:ext>
            </a:extLst>
          </p:cNvPr>
          <p:cNvSpPr txBox="1"/>
          <p:nvPr/>
        </p:nvSpPr>
        <p:spPr>
          <a:xfrm>
            <a:off x="142051" y="167463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716917F-5814-9F4C-8D4D-D3FF05888EFD}"/>
              </a:ext>
            </a:extLst>
          </p:cNvPr>
          <p:cNvSpPr txBox="1"/>
          <p:nvPr/>
        </p:nvSpPr>
        <p:spPr>
          <a:xfrm>
            <a:off x="142051" y="30326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 descr="A picture containing indoor, blur&#10;&#10;Description automatically generated">
            <a:extLst>
              <a:ext uri="{FF2B5EF4-FFF2-40B4-BE49-F238E27FC236}">
                <a16:creationId xmlns:a16="http://schemas.microsoft.com/office/drawing/2014/main" id="{E14DBA96-0D57-4C49-AD33-057697533E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" r="42021"/>
          <a:stretch/>
        </p:blipFill>
        <p:spPr>
          <a:xfrm>
            <a:off x="1365924" y="460953"/>
            <a:ext cx="1056189" cy="108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2C25C5-5437-4E4D-8E26-EF925C628EF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3733"/>
          <a:stretch/>
        </p:blipFill>
        <p:spPr>
          <a:xfrm>
            <a:off x="3569701" y="460953"/>
            <a:ext cx="1128795" cy="1080000"/>
          </a:xfrm>
          <a:prstGeom prst="rect">
            <a:avLst/>
          </a:prstGeom>
        </p:spPr>
      </p:pic>
      <p:pic>
        <p:nvPicPr>
          <p:cNvPr id="26" name="Picture 25" descr="A picture containing indoor, blur&#10;&#10;Description automatically generated">
            <a:extLst>
              <a:ext uri="{FF2B5EF4-FFF2-40B4-BE49-F238E27FC236}">
                <a16:creationId xmlns:a16="http://schemas.microsoft.com/office/drawing/2014/main" id="{D41BE729-81E4-D748-9BDB-34780025FB7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50000"/>
          <a:stretch/>
        </p:blipFill>
        <p:spPr>
          <a:xfrm>
            <a:off x="2589817" y="1888486"/>
            <a:ext cx="1249157" cy="1080000"/>
          </a:xfrm>
          <a:prstGeom prst="rect">
            <a:avLst/>
          </a:prstGeom>
        </p:spPr>
      </p:pic>
      <p:pic>
        <p:nvPicPr>
          <p:cNvPr id="28" name="Picture 27" descr="A picture containing text, light, way, traffic&#10;&#10;Description automatically generated">
            <a:extLst>
              <a:ext uri="{FF2B5EF4-FFF2-40B4-BE49-F238E27FC236}">
                <a16:creationId xmlns:a16="http://schemas.microsoft.com/office/drawing/2014/main" id="{7B2D022C-AD6C-404C-B118-5B74D243117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1562" r="43111"/>
          <a:stretch/>
        </p:blipFill>
        <p:spPr>
          <a:xfrm>
            <a:off x="2564463" y="3329979"/>
            <a:ext cx="1651674" cy="1080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E049C77-CEC8-5640-8E6A-7925F88CA51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0154" y="1856817"/>
            <a:ext cx="1581778" cy="404526"/>
          </a:xfrm>
          <a:prstGeom prst="rect">
            <a:avLst/>
          </a:prstGeom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E1ED0789-5E3D-8541-A985-85C1C7741A52}"/>
              </a:ext>
            </a:extLst>
          </p:cNvPr>
          <p:cNvGrpSpPr/>
          <p:nvPr/>
        </p:nvGrpSpPr>
        <p:grpSpPr>
          <a:xfrm>
            <a:off x="4103617" y="2285328"/>
            <a:ext cx="1775310" cy="536851"/>
            <a:chOff x="5548226" y="4534163"/>
            <a:chExt cx="1775310" cy="536851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32156AF-CD20-FA4A-9480-5351CD7AD2C6}"/>
                </a:ext>
              </a:extLst>
            </p:cNvPr>
            <p:cNvSpPr txBox="1"/>
            <p:nvPr/>
          </p:nvSpPr>
          <p:spPr>
            <a:xfrm>
              <a:off x="5670337" y="4534163"/>
              <a:ext cx="7505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FMO contro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AE82525-E577-3B42-8961-7C471D54D326}"/>
                </a:ext>
              </a:extLst>
            </p:cNvPr>
            <p:cNvSpPr txBox="1"/>
            <p:nvPr/>
          </p:nvSpPr>
          <p:spPr>
            <a:xfrm>
              <a:off x="5663285" y="4704941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allo-HCT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C255860-3AD5-684B-A61A-0B00529F0779}"/>
                </a:ext>
              </a:extLst>
            </p:cNvPr>
            <p:cNvSpPr txBox="1"/>
            <p:nvPr/>
          </p:nvSpPr>
          <p:spPr>
            <a:xfrm>
              <a:off x="5666142" y="4855570"/>
              <a:ext cx="16573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allo-HCT (Transplanted mLNs)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CF6E21C2-2108-FD45-9352-F46D363358B7}"/>
                </a:ext>
              </a:extLst>
            </p:cNvPr>
            <p:cNvCxnSpPr>
              <a:cxnSpLocks/>
            </p:cNvCxnSpPr>
            <p:nvPr/>
          </p:nvCxnSpPr>
          <p:spPr>
            <a:xfrm>
              <a:off x="5548718" y="4813869"/>
              <a:ext cx="150329" cy="0"/>
            </a:xfrm>
            <a:prstGeom prst="line">
              <a:avLst/>
            </a:prstGeom>
            <a:ln w="19050">
              <a:solidFill>
                <a:srgbClr val="3C17E8"/>
              </a:solidFill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AEF8ADE9-12B4-844F-8C0C-F5902709B0BC}"/>
                </a:ext>
              </a:extLst>
            </p:cNvPr>
            <p:cNvCxnSpPr>
              <a:cxnSpLocks/>
            </p:cNvCxnSpPr>
            <p:nvPr/>
          </p:nvCxnSpPr>
          <p:spPr>
            <a:xfrm>
              <a:off x="5548226" y="4961167"/>
              <a:ext cx="150329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FA86F5A6-2B87-C34B-8AB4-E4BFC148F8B4}"/>
                </a:ext>
              </a:extLst>
            </p:cNvPr>
            <p:cNvSpPr/>
            <p:nvPr/>
          </p:nvSpPr>
          <p:spPr>
            <a:xfrm>
              <a:off x="5548717" y="4611018"/>
              <a:ext cx="144000" cy="720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6A40949E-6663-3745-823A-89EC6FD59F3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49501"/>
          <a:stretch/>
        </p:blipFill>
        <p:spPr>
          <a:xfrm>
            <a:off x="466486" y="6266723"/>
            <a:ext cx="2115527" cy="1098449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4336D615-ED13-C64A-A2CB-86D3806DB2D7}"/>
              </a:ext>
            </a:extLst>
          </p:cNvPr>
          <p:cNvSpPr txBox="1"/>
          <p:nvPr/>
        </p:nvSpPr>
        <p:spPr>
          <a:xfrm>
            <a:off x="840598" y="6102655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6.W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EB0FB7C-F4D4-B14A-B41D-DCE4B36E50C3}"/>
              </a:ext>
            </a:extLst>
          </p:cNvPr>
          <p:cNvSpPr txBox="1"/>
          <p:nvPr/>
        </p:nvSpPr>
        <p:spPr>
          <a:xfrm>
            <a:off x="1659896" y="6099580"/>
            <a:ext cx="9172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6.CD11c.DO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8F7C1E6-8D62-494D-8FAD-17EB9C25600D}"/>
              </a:ext>
            </a:extLst>
          </p:cNvPr>
          <p:cNvSpPr txBox="1"/>
          <p:nvPr/>
        </p:nvSpPr>
        <p:spPr>
          <a:xfrm>
            <a:off x="327782" y="7527042"/>
            <a:ext cx="6306261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 | Depletion of CD11c</a:t>
            </a:r>
            <a:r>
              <a:rPr lang="en-GB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cells in CD11c.DOG mous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CD11c.DOG mice were given diphtheria toxin (20 ng/gram body weight) on day -5, -3 and -1 and on day 0 mLNs were isolated for surgical transplantation. Frequency of CD11c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HCII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ells was analyzed on day 0 by pre-gating on living singlets and CD45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ells. Each data point represents one mouse, data pooled from two experiments; unpaired non-parametric Mann-Whitney test, (Mean± SD); *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&lt; </a:t>
            </a:r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0.05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A picture containing indoor, light, blur&#10;&#10;Description automatically generated">
            <a:extLst>
              <a:ext uri="{FF2B5EF4-FFF2-40B4-BE49-F238E27FC236}">
                <a16:creationId xmlns:a16="http://schemas.microsoft.com/office/drawing/2014/main" id="{722A7D09-90E9-5F46-97A8-DEA2C8DB88A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88173" y="6236180"/>
            <a:ext cx="172125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676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696</Words>
  <Application>Microsoft Macintosh PowerPoint</Application>
  <PresentationFormat>A4 Paper (210x297 mm)</PresentationFormat>
  <Paragraphs>6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hammad Haroon Shaikh</dc:creator>
  <cp:lastModifiedBy>Haroon Shaikh</cp:lastModifiedBy>
  <cp:revision>147</cp:revision>
  <dcterms:created xsi:type="dcterms:W3CDTF">2019-06-03T07:00:19Z</dcterms:created>
  <dcterms:modified xsi:type="dcterms:W3CDTF">2021-07-05T08:31:25Z</dcterms:modified>
</cp:coreProperties>
</file>